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E4F010-C395-4326-AD58-11707A08CB2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D7BF4-1A35-496F-B22A-8C2FF3C956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975D61-4259-4B8B-BCDD-E07D53D9BF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91062-29DF-4418-A936-C935FC1AB55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A259D5-29BF-4C15-A6D8-75787059CE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D456E-BE89-4BA7-BB12-C07783F5597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EE6D78-8F6C-4D78-9882-C0B464C4836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3A84C5-BEE5-458C-BF3B-8A5176A152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2F8214-2A3D-4902-B0A7-61818AD87A6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CC73EF-7F7A-429B-A924-975FC632C9E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4B30F8-2A36-413B-93AE-37CBDE819F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08CF7-027C-49A0-9C6E-AFED291251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194CBDB-46B7-413D-A578-7C3C6BEB4B6A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2195640" y="2479680"/>
            <a:ext cx="10969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GAPDH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4"/>
          <p:cNvSpPr/>
          <p:nvPr/>
        </p:nvSpPr>
        <p:spPr>
          <a:xfrm>
            <a:off x="2278080" y="1628640"/>
            <a:ext cx="1014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Notch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9"/>
          <p:cNvSpPr/>
          <p:nvPr/>
        </p:nvSpPr>
        <p:spPr>
          <a:xfrm>
            <a:off x="2328840" y="2068560"/>
            <a:ext cx="13604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p-AKT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7" descr=""/>
          <p:cNvPicPr/>
          <p:nvPr/>
        </p:nvPicPr>
        <p:blipFill>
          <a:blip r:embed="rId1">
            <a:grayscl/>
            <a:lum contrast="40000"/>
          </a:blip>
          <a:srcRect l="3991" t="23640" r="12023" b="11445"/>
          <a:stretch/>
        </p:blipFill>
        <p:spPr>
          <a:xfrm>
            <a:off x="3095640" y="2509920"/>
            <a:ext cx="3819600" cy="3236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5" name="直接连接符 6"/>
          <p:cNvSpPr/>
          <p:nvPr/>
        </p:nvSpPr>
        <p:spPr>
          <a:xfrm>
            <a:off x="3206880" y="3022560"/>
            <a:ext cx="140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直接连接符 8"/>
          <p:cNvSpPr/>
          <p:nvPr/>
        </p:nvSpPr>
        <p:spPr>
          <a:xfrm>
            <a:off x="4808520" y="3022560"/>
            <a:ext cx="15843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TextBox 10"/>
          <p:cNvSpPr/>
          <p:nvPr/>
        </p:nvSpPr>
        <p:spPr>
          <a:xfrm>
            <a:off x="3501720" y="3129120"/>
            <a:ext cx="840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Vector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TextBox 22"/>
          <p:cNvSpPr/>
          <p:nvPr/>
        </p:nvSpPr>
        <p:spPr>
          <a:xfrm>
            <a:off x="5159160" y="3129120"/>
            <a:ext cx="674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Jag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5" descr=""/>
          <p:cNvPicPr/>
          <p:nvPr/>
        </p:nvPicPr>
        <p:blipFill>
          <a:blip r:embed="rId2">
            <a:grayscl/>
            <a:lum contrast="40000"/>
          </a:blip>
          <a:srcRect l="13277" t="19260" r="11128" b="31774"/>
          <a:stretch/>
        </p:blipFill>
        <p:spPr>
          <a:xfrm>
            <a:off x="3095640" y="1658880"/>
            <a:ext cx="381960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0" name="直接连接符 17"/>
          <p:cNvSpPr/>
          <p:nvPr/>
        </p:nvSpPr>
        <p:spPr>
          <a:xfrm>
            <a:off x="6564240" y="3022560"/>
            <a:ext cx="309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矩形 1"/>
          <p:cNvSpPr/>
          <p:nvPr/>
        </p:nvSpPr>
        <p:spPr>
          <a:xfrm>
            <a:off x="339840" y="4581360"/>
            <a:ext cx="855324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600" spc="-1" strike="noStrike">
                <a:solidFill>
                  <a:srgbClr val="000000"/>
                </a:solidFill>
                <a:latin typeface="Arial"/>
              </a:rPr>
              <a:t>Supplementary Figure 3. </a:t>
            </a:r>
            <a:r>
              <a:rPr b="0" lang="de-DE" sz="1600" spc="-1" strike="noStrike">
                <a:solidFill>
                  <a:srgbClr val="000000"/>
                </a:solidFill>
                <a:latin typeface="Arial"/>
                <a:ea typeface="Arial"/>
              </a:rPr>
              <a:t>O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verexpression of Jag1 alone does not lead to increased Notch2 or phosphorylated/activated AKT (p-AKT) levels in the mouse liver. Livers injected with empty vector (Vector) and Jag1 construct (Jag1) were analysed by Western blot analysis. (+): Positive control, liver tissues from a PIK3CAH1047R injected mouse showing elevated expression of p-AKT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2" name="Picture 3" descr=""/>
          <p:cNvPicPr/>
          <p:nvPr/>
        </p:nvPicPr>
        <p:blipFill>
          <a:blip r:embed="rId3">
            <a:grayscl/>
            <a:lum contrast="40000"/>
          </a:blip>
          <a:srcRect l="20346" t="16788" r="1521" b="24270"/>
          <a:stretch/>
        </p:blipFill>
        <p:spPr>
          <a:xfrm>
            <a:off x="3095640" y="2084400"/>
            <a:ext cx="3819600" cy="3240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3" name="TextBox 12"/>
          <p:cNvSpPr/>
          <p:nvPr/>
        </p:nvSpPr>
        <p:spPr>
          <a:xfrm>
            <a:off x="6167520" y="3129120"/>
            <a:ext cx="10033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(+) contro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0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9-21T00:01:21Z</dcterms:created>
  <dc:creator>li che</dc:creator>
  <dc:description/>
  <dc:language>en-US</dc:language>
  <cp:lastModifiedBy>xin chen lab</cp:lastModifiedBy>
  <dcterms:modified xsi:type="dcterms:W3CDTF">2016-09-26T17:00:00Z</dcterms:modified>
  <cp:revision>25</cp:revision>
  <dc:subject/>
  <dc:title>PowerPoint 演示文稿</dc:title>
</cp:coreProperties>
</file>